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60" r:id="rId3"/>
    <p:sldId id="262" r:id="rId4"/>
    <p:sldId id="261" r:id="rId5"/>
    <p:sldId id="263" r:id="rId6"/>
    <p:sldId id="264" r:id="rId7"/>
    <p:sldId id="265" r:id="rId8"/>
    <p:sldId id="266" r:id="rId9"/>
    <p:sldId id="267" r:id="rId10"/>
    <p:sldId id="268" r:id="rId11"/>
    <p:sldId id="269" r:id="rId12"/>
    <p:sldId id="270" r:id="rId13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0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276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20" y="72"/>
      </p:cViewPr>
      <p:guideLst>
        <p:guide orient="horz" pos="100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6441-A966-48DB-85C4-BA6BC9D194F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80969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26DC8-E51D-481D-AAD8-A43A9DFD3B2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148115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BD760-98FC-4C08-A0F8-5A963CD3BC8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040279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79005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949C4-1DE5-4F70-8142-6CF1BB24FEA7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720956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8FA0B-0612-4E20-BCBE-87F7BED20B0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954897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D3FC5-249B-4B4C-A869-F27D2287A69E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082196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286D-970A-40DF-86E4-A03FBAF9B186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052769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B30D-BE39-4293-9BDC-450C31B1B31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13342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4F7FA-888C-4CDC-ACC9-A1F66DFE1ECB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88965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14D75-D436-47E2-BF8B-27FD76561BE0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588006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56513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3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  <p:pic>
        <p:nvPicPr>
          <p:cNvPr id="11" name="Obrázek 1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541358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5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20</a:t>
            </a:r>
            <a:endParaRPr lang="cs-CZ" b="1" dirty="0"/>
          </a:p>
        </p:txBody>
      </p:sp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720324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24" name="TextovéPole 2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13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6</a:t>
            </a:r>
            <a:endParaRPr lang="cs-CZ" b="1" dirty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141164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8</a:t>
            </a:r>
            <a:r>
              <a:rPr lang="en-US" dirty="0" smtClean="0"/>
              <a:t>, order: </a:t>
            </a:r>
            <a:r>
              <a:rPr lang="en-US" b="1" dirty="0" smtClean="0"/>
              <a:t>2</a:t>
            </a:r>
            <a:r>
              <a:rPr lang="en-US" dirty="0" smtClean="0"/>
              <a:t>, half-width: 4</a:t>
            </a:r>
            <a:endParaRPr lang="cs-CZ" b="1" dirty="0"/>
          </a:p>
        </p:txBody>
      </p:sp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456268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5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20</a:t>
            </a:r>
            <a:endParaRPr lang="cs-CZ" b="1" dirty="0"/>
          </a:p>
        </p:txBody>
      </p:sp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7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24343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24" name="TextovéPole 2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13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6</a:t>
            </a:r>
            <a:endParaRPr lang="cs-CZ" b="1" dirty="0"/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502349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8</a:t>
            </a:r>
            <a:r>
              <a:rPr lang="en-US" dirty="0" smtClean="0"/>
              <a:t>, order: </a:t>
            </a:r>
            <a:r>
              <a:rPr lang="en-US" b="1" dirty="0" smtClean="0"/>
              <a:t>2</a:t>
            </a:r>
            <a:r>
              <a:rPr lang="en-US" dirty="0" smtClean="0"/>
              <a:t>, half-width: 4</a:t>
            </a:r>
            <a:endParaRPr lang="cs-CZ" b="1" dirty="0"/>
          </a:p>
        </p:txBody>
      </p:sp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474083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640514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5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20</a:t>
            </a:r>
            <a:endParaRPr lang="cs-CZ" b="1" dirty="0"/>
          </a:p>
        </p:txBody>
      </p:sp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864024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24" name="TextovéPole 2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13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6</a:t>
            </a:r>
            <a:endParaRPr lang="cs-CZ" b="1" dirty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67026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8</a:t>
            </a:r>
            <a:r>
              <a:rPr lang="en-US" dirty="0" smtClean="0"/>
              <a:t>, order: </a:t>
            </a:r>
            <a:r>
              <a:rPr lang="en-US" b="1" dirty="0" smtClean="0"/>
              <a:t>2</a:t>
            </a:r>
            <a:r>
              <a:rPr lang="en-US" dirty="0" smtClean="0"/>
              <a:t>, half-width: 4</a:t>
            </a:r>
            <a:endParaRPr lang="cs-CZ" b="1" dirty="0"/>
          </a:p>
        </p:txBody>
      </p:sp>
      <p:sp>
        <p:nvSpPr>
          <p:cNvPr id="23" name="Volný tvar 22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788205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idth of the central stripe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516835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 advClick="0"/>
    </mc:Choice>
    <mc:Fallback>
      <p:transition advClick="0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</TotalTime>
  <Words>528</Words>
  <Application>Microsoft Office PowerPoint</Application>
  <PresentationFormat>Předvádění na obrazovce (4:3)</PresentationFormat>
  <Paragraphs>45</Paragraphs>
  <Slides>12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6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DejaVu Sans</vt:lpstr>
      <vt:lpstr>Lohit Hindi</vt:lpstr>
      <vt:lpstr>Tahoma</vt:lpstr>
      <vt:lpstr>Defaul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>UBBP 1. LF U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bomir Kovacik</dc:creator>
  <cp:lastModifiedBy>Lubomir Kovacik</cp:lastModifiedBy>
  <cp:revision>26</cp:revision>
  <dcterms:created xsi:type="dcterms:W3CDTF">2014-01-07T09:01:08Z</dcterms:created>
  <dcterms:modified xsi:type="dcterms:W3CDTF">2014-01-07T11:43:38Z</dcterms:modified>
</cp:coreProperties>
</file>